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0" d="100"/>
          <a:sy n="80" d="100"/>
        </p:scale>
        <p:origin x="68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6852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3709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43362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696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7365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9393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5025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38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7691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6940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649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D799D0-C38D-4985-A3ED-E06898E67E2D}" type="datetimeFigureOut">
              <a:rPr lang="en-US" smtClean="0"/>
              <a:t>2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D86976-D529-4465-946F-0AA880525D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121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925804" y="3402857"/>
            <a:ext cx="53412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Sodium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etat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373951" y="3404082"/>
            <a:ext cx="4924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erulic</a:t>
            </a:r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id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7926471" y="1167358"/>
            <a:ext cx="202331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DPN1: </a:t>
            </a:r>
            <a:r>
              <a:rPr lang="en-US" sz="800" i="1" dirty="0" err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r>
              <a:rPr lang="en-US" sz="800" i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BRCY73 x </a:t>
            </a:r>
            <a:r>
              <a:rPr lang="en-US" sz="800" i="1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 </a:t>
            </a:r>
            <a:r>
              <a:rPr lang="en-US" sz="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O1815</a:t>
            </a:r>
            <a:endParaRPr lang="en-US" sz="8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926471" y="2310516"/>
            <a:ext cx="198964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DPN5: </a:t>
            </a:r>
            <a:r>
              <a:rPr lang="en-US" sz="800" i="1" dirty="0" err="1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</a:t>
            </a:r>
            <a:r>
              <a:rPr lang="en-US" sz="800" i="1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BRCY73 x </a:t>
            </a:r>
            <a:r>
              <a:rPr lang="en-US" sz="800" i="1" dirty="0" err="1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k</a:t>
            </a:r>
            <a:r>
              <a:rPr lang="en-US" sz="800" i="1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800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FO1802</a:t>
            </a:r>
            <a:endParaRPr lang="en-US" sz="800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7929991" y="2902945"/>
            <a:ext cx="15520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DPN379: Evolved yHDPN5</a:t>
            </a:r>
            <a:endParaRPr lang="en-US" sz="800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7936519" y="1774616"/>
            <a:ext cx="15520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DPN399: Evolved yHDPN1</a:t>
            </a:r>
            <a:endParaRPr lang="en-US" sz="8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7926471" y="594695"/>
            <a:ext cx="7232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BRCY73</a:t>
            </a:r>
            <a:endParaRPr lang="en-US" sz="800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"/>
          <a:srcRect l="1" r="65315"/>
          <a:stretch/>
        </p:blipFill>
        <p:spPr>
          <a:xfrm>
            <a:off x="147617" y="256230"/>
            <a:ext cx="176233" cy="1930875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90098" y="19353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µ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551734" y="3402178"/>
            <a:ext cx="6719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etamid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5248818" y="3404947"/>
            <a:ext cx="4651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355854" y="3406620"/>
            <a:ext cx="5501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Feruloyl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mid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313883" y="3402045"/>
            <a:ext cx="12025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ll Hydrolysate Toxins</a:t>
            </a:r>
          </a:p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(HTs)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929461" y="3403964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697204" y="3402244"/>
            <a:ext cx="7152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umaric</a:t>
            </a:r>
            <a:endParaRPr lang="en-U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133634" y="3402244"/>
            <a:ext cx="4058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MF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4420623" y="3399403"/>
            <a:ext cx="7040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umaroyl</a:t>
            </a:r>
            <a:endParaRPr lang="en-US" sz="8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Amide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34883" y="19354"/>
            <a:ext cx="7155741" cy="326873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45959" y="218130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12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52886" y="1971699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11191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2</TotalTime>
  <Words>46</Words>
  <Application>Microsoft Office PowerPoint</Application>
  <PresentationFormat>Widescreen</PresentationFormat>
  <Paragraphs>2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VE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16</cp:revision>
  <dcterms:created xsi:type="dcterms:W3CDTF">2016-06-04T01:01:03Z</dcterms:created>
  <dcterms:modified xsi:type="dcterms:W3CDTF">2017-02-21T00:03:42Z</dcterms:modified>
</cp:coreProperties>
</file>